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-102" y="-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619698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0700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29095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61641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62620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64771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867500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23251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80432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875252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77150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39303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07710" y="14778"/>
            <a:ext cx="4097542" cy="3380597"/>
          </a:xfr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85519" y="44335"/>
            <a:ext cx="4127183" cy="334677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67696" y="3391105"/>
            <a:ext cx="4037556" cy="3317265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85519" y="3388489"/>
            <a:ext cx="4206083" cy="346951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9176171" y="4779167"/>
            <a:ext cx="2892829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Supplementary figure 4. ROC curve in obese subgroup </a:t>
            </a:r>
          </a:p>
          <a:p>
            <a:endParaRPr lang="en-US" altLang="ko-KR" sz="1400" dirty="0" smtClean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2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4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6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8 year follow up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5859" y="44335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a)</a:t>
            </a:r>
            <a:endParaRPr lang="ko-KR" alt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4689516" y="44335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b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251374" y="3274049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c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4689515" y="3274049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d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xmlns="" val="26617137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33</Words>
  <Application>Microsoft Office PowerPoint</Application>
  <PresentationFormat>사용자 지정</PresentationFormat>
  <Paragraphs>1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박성근</cp:lastModifiedBy>
  <cp:revision>18</cp:revision>
  <dcterms:created xsi:type="dcterms:W3CDTF">2024-01-24T23:55:32Z</dcterms:created>
  <dcterms:modified xsi:type="dcterms:W3CDTF">2024-05-04T11:12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</Properties>
</file>